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05"/>
    <p:restoredTop sz="94697"/>
  </p:normalViewPr>
  <p:slideViewPr>
    <p:cSldViewPr snapToGrid="0" snapToObjects="1">
      <p:cViewPr varScale="1">
        <p:scale>
          <a:sx n="56" d="100"/>
          <a:sy n="56" d="100"/>
        </p:scale>
        <p:origin x="216" y="1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9811E-E01D-FD4F-B378-F83671E6BE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11E3A3-3DE7-824F-81A6-EDBD27F83B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0C7D9A-AFD4-6F48-91E4-319C0084D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1FC02A-F82D-9E4A-94E3-E0162F513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1070D0-7489-B444-AD02-E45415D1F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289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522EB-4967-8343-B148-1124C36047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805BBA-CD16-E04F-8439-93C5B23F45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914A62-1983-2F42-9F58-3BDF6EC1D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5AD622-76B4-494D-A034-C4318F3F5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3104C2-B128-EE41-9F5C-0A16D96B1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174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7B16DD-3C54-3943-A404-A1658AFB8B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AAEADE-A4C2-BD40-BFB9-E3FEE4B03E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AC41E7-93E1-B148-8EB0-6488A265C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248EE-4BEC-4448-9D77-5CBAA8E16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C08F40-954C-D44F-BE3D-E3FE7AFB6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79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4F0BC-3C2E-0A4D-B11F-DEB9412FA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9886BF-591E-8C45-AF4C-FA91D4B8DD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17645-B259-2944-9A80-5F03D3090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CF211-6784-304C-9F2A-8CF799059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3AE962-F82D-A644-9D51-8DD6C0120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247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B5F1BD-A473-F44A-93D8-8A3EF1F4ED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A2E9A2-5EF7-734B-8B10-F404B4C927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B0815A-BB8B-E44F-BC97-2DD884572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AE4CB-BED7-A14E-AA3B-319C866AE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2BA42D-4144-E541-89C8-2800F3417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186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B3A3A-4A6F-7F4A-A858-5045079335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307E07-93D9-6145-ABE2-1B4BA7F15B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74842F-B3F6-6A4F-8C9F-874F2B7827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A73033-C3BF-9146-8FE8-E7FF26E44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4CE03B-48BA-E649-8452-16BC8E645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BFFC8A-B3D9-4D41-84A2-1F4A7D392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69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AD7FD-AC0C-4B4A-B8C7-46C8B04E6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5E946D-D603-E640-AE0A-63B43FCCEA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4425F9-695A-254D-92B0-4AA3E0D622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CFDAEA-9C3C-454D-932B-5EBF51A429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9CEC0B-A67A-B544-9E7E-262715079F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956EDE-39DB-B74B-A797-6EB21E62E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89A0EE-8EA3-2B4D-813B-131F8BF64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86F97E-EA30-5848-BFED-CA336B50F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024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AFA19B-C128-8940-B20E-F0C031B19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7386BF-3985-CB40-B6F0-966C5FFBE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ED93FE-D9E5-B644-B558-F9B1E7D4C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CA6143-615A-2B48-A26A-45CE2E357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421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91B09C-6D69-BE4D-9503-88B5AB24D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30F49F-3547-AD4A-9EEC-1A170377E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92AE1E-0C95-D545-B0B7-DD4886C89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64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11540-C8CF-7845-A535-A1247A46E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28E32D-A19B-0141-9530-D2A7FD6336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93B327-E446-0246-91EC-740049EE19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B7F83A-72D1-154F-B998-217CFF68F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C4631F-66B9-E643-BD1C-A2D458070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DDFBC7-F5A4-5F47-AB66-3A3AD38FE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52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B09BC-6424-5B49-8E36-24C1C10DA1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3F793D-CF60-8B42-90C5-C8414F9B8C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97EA0F-92B4-7D47-A6BC-5CC6ED5623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09BC25-AA68-7C4E-9BAD-430704437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3288F4-CCED-DC47-ABD8-A40A98EBA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6262D8-C1F9-AC4D-8EC3-AA0D1D5AD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08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692654-01DD-774A-8120-5377A0656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4D7EAC-5FD7-4949-A448-2939B449CF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86D6AD-5069-DC40-8C8A-C6383E3DA5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88AB6-7163-BC4D-AFA7-23C6B203C9E7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70DE77-23FC-1D49-AC87-AE4B35F8C5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80B701-D0D4-6242-9FFF-9A739FA584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01003-FF79-9342-B8D1-7055D5956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134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3B8244-10E1-7F4E-A48F-01828E1A66B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1EAAF5-9222-1548-85F9-B55965EA6F3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1172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BF6A51-75C1-F549-A6F3-7BCF2E5BFC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527DBD-3E49-A44C-8456-8E25857E6C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White blood count (WBC)</a:t>
            </a:r>
            <a:r>
              <a:rPr lang="en-US" b="1" dirty="0"/>
              <a:t> 		16.2 x1000/mm^3 (H)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Hemoglobin (Hgb)				11.2 g/dL</a:t>
            </a:r>
          </a:p>
          <a:p>
            <a:pPr marL="0" indent="0">
              <a:buNone/>
            </a:pPr>
            <a:r>
              <a:rPr lang="en-US" dirty="0"/>
              <a:t>Hematocrit (HCT)				34.4%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					400 x1000/mm^3</a:t>
            </a:r>
          </a:p>
          <a:p>
            <a:pPr marL="0" indent="0">
              <a:buNone/>
            </a:pPr>
            <a:r>
              <a:rPr lang="en-US" dirty="0"/>
              <a:t>Segs:						</a:t>
            </a:r>
            <a:r>
              <a:rPr lang="en-US" b="1" dirty="0"/>
              <a:t>88%</a:t>
            </a:r>
            <a:endParaRPr lang="en-US" dirty="0"/>
          </a:p>
          <a:p>
            <a:pPr marL="0" indent="0">
              <a:buNone/>
            </a:pPr>
            <a:r>
              <a:rPr lang="en-US" dirty="0" err="1"/>
              <a:t>Lymphs</a:t>
            </a:r>
            <a:r>
              <a:rPr lang="en-US" dirty="0"/>
              <a:t>:					6%</a:t>
            </a:r>
          </a:p>
          <a:p>
            <a:pPr marL="0" indent="0">
              <a:buNone/>
            </a:pPr>
            <a:r>
              <a:rPr lang="en-US" dirty="0" err="1"/>
              <a:t>Monos</a:t>
            </a:r>
            <a:r>
              <a:rPr lang="en-US" dirty="0"/>
              <a:t>:					4%</a:t>
            </a:r>
          </a:p>
          <a:p>
            <a:pPr marL="0" indent="0">
              <a:buNone/>
            </a:pPr>
            <a:r>
              <a:rPr lang="en-US" dirty="0"/>
              <a:t>Eos:						2%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27901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CDB21-552F-414F-8628-BE252382D1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82DE28-C973-A547-A06E-E83C2B9178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Sodium					</a:t>
            </a:r>
            <a:r>
              <a:rPr lang="en-US" b="1" dirty="0"/>
              <a:t>132 </a:t>
            </a:r>
            <a:r>
              <a:rPr lang="en-US" b="1" dirty="0" err="1"/>
              <a:t>mEq</a:t>
            </a:r>
            <a:r>
              <a:rPr lang="en-US" b="1" dirty="0"/>
              <a:t>/L (L)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Potassium					3.7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Chloride					</a:t>
            </a:r>
            <a:r>
              <a:rPr lang="en-US" b="1" dirty="0"/>
              <a:t>98 </a:t>
            </a:r>
            <a:r>
              <a:rPr lang="en-US" b="1" dirty="0" err="1"/>
              <a:t>mEq</a:t>
            </a:r>
            <a:r>
              <a:rPr lang="en-US" b="1" dirty="0"/>
              <a:t>/L (L)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Bicarbonate (HCO3)			</a:t>
            </a:r>
            <a:r>
              <a:rPr lang="en-US" b="1" dirty="0"/>
              <a:t>11 </a:t>
            </a:r>
            <a:r>
              <a:rPr lang="en-US" b="1" dirty="0" err="1"/>
              <a:t>mEq</a:t>
            </a:r>
            <a:r>
              <a:rPr lang="en-US" b="1" dirty="0"/>
              <a:t>/L (L)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Blood urea nitrogen (BUN)		</a:t>
            </a:r>
            <a:r>
              <a:rPr lang="en-US" b="1" dirty="0"/>
              <a:t>34 mg/dL (H)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Creatinine (Cr)				</a:t>
            </a:r>
            <a:r>
              <a:rPr lang="en-US" b="1" dirty="0"/>
              <a:t>2.4 mg/dL (H)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Glucose 					95 m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07200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FEB8D-4107-4543-B981-A334C34310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at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1F1B45-CB14-FE47-8DC6-21112FB449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8.7 mmol/L (H)</a:t>
            </a:r>
          </a:p>
        </p:txBody>
      </p:sp>
    </p:spTree>
    <p:extLst>
      <p:ext uri="{BB962C8B-B14F-4D97-AF65-F5344CB8AC3E}">
        <p14:creationId xmlns:p14="http://schemas.microsoft.com/office/powerpoint/2010/main" val="32768196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F0269-9A07-1A45-8E5F-02952F19D1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cardiogram</a:t>
            </a:r>
          </a:p>
        </p:txBody>
      </p:sp>
      <p:pic>
        <p:nvPicPr>
          <p:cNvPr id="4" name="image1.jpg" descr="A picture containing text, measuring stick&#10;&#10;Description automatically generated">
            <a:extLst>
              <a:ext uri="{FF2B5EF4-FFF2-40B4-BE49-F238E27FC236}">
                <a16:creationId xmlns:a16="http://schemas.microsoft.com/office/drawing/2014/main" id="{83E3E21B-91AD-A447-9C5C-168137D95EF1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1272540" y="1484947"/>
            <a:ext cx="9646920" cy="4802187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27474688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D74B8B-FF79-394F-AFD9-60B616B1E6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Transthoracic echocardiogram</a:t>
            </a:r>
            <a:br>
              <a:rPr lang="en-US" dirty="0"/>
            </a:br>
            <a:r>
              <a:rPr lang="en-US" dirty="0"/>
              <a:t>Parasternal long: cardiac standstill (indicator left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CC77E2-BE5F-C949-8B9B-9589B99EDF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image2.png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9B4BC3EA-B1F2-384F-8E74-7D1CCB136F0F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2552700" y="1825625"/>
            <a:ext cx="7086600" cy="4741227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7766300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8CD927-5F59-0C4E-AD63-70EE6DB7A4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Transthoracic echocardiogram</a:t>
            </a:r>
            <a:br>
              <a:rPr lang="en-US" dirty="0"/>
            </a:br>
            <a:r>
              <a:rPr lang="en-US" dirty="0"/>
              <a:t>Parasternal long: cardiac standstill (indicator right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0D6075-E6CF-6048-90BD-8DF63852CC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image8.png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0F51A961-B1FD-9A4B-9A61-E2F707F1FCF5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2514600" y="1719263"/>
            <a:ext cx="6697980" cy="4773612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309093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29</Words>
  <Application>Microsoft Macintosh PowerPoint</Application>
  <PresentationFormat>Widescreen</PresentationFormat>
  <Paragraphs>2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Stimulus Inventory</vt:lpstr>
      <vt:lpstr>Complete Blood Count (CBC)</vt:lpstr>
      <vt:lpstr>Basic Metabolic Panel (BMP)</vt:lpstr>
      <vt:lpstr>Lactate</vt:lpstr>
      <vt:lpstr>Electrocardiogram</vt:lpstr>
      <vt:lpstr>Transthoracic echocardiogram Parasternal long: cardiac standstill (indicator left)</vt:lpstr>
      <vt:lpstr>Transthoracic echocardiogram Parasternal long: cardiac standstill (indicator right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Low, Cheyenne</dc:creator>
  <cp:lastModifiedBy>Low, Cheyenne</cp:lastModifiedBy>
  <cp:revision>1</cp:revision>
  <dcterms:created xsi:type="dcterms:W3CDTF">2022-03-02T21:45:15Z</dcterms:created>
  <dcterms:modified xsi:type="dcterms:W3CDTF">2022-03-02T21:51:37Z</dcterms:modified>
</cp:coreProperties>
</file>